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342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333E2C-C174-4526-BF7C-3B09263359BB}" type="datetimeFigureOut">
              <a:rPr lang="en-US" smtClean="0"/>
              <a:t>11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F04226-CC07-4248-AB56-E085485CA8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72879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333E2C-C174-4526-BF7C-3B09263359BB}" type="datetimeFigureOut">
              <a:rPr lang="en-US" smtClean="0"/>
              <a:t>11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F04226-CC07-4248-AB56-E085485CA8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51784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333E2C-C174-4526-BF7C-3B09263359BB}" type="datetimeFigureOut">
              <a:rPr lang="en-US" smtClean="0"/>
              <a:t>11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F04226-CC07-4248-AB56-E085485CA8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4096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333E2C-C174-4526-BF7C-3B09263359BB}" type="datetimeFigureOut">
              <a:rPr lang="en-US" smtClean="0"/>
              <a:t>11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F04226-CC07-4248-AB56-E085485CA8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78741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333E2C-C174-4526-BF7C-3B09263359BB}" type="datetimeFigureOut">
              <a:rPr lang="en-US" smtClean="0"/>
              <a:t>11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F04226-CC07-4248-AB56-E085485CA8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49353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333E2C-C174-4526-BF7C-3B09263359BB}" type="datetimeFigureOut">
              <a:rPr lang="en-US" smtClean="0"/>
              <a:t>11/30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F04226-CC07-4248-AB56-E085485CA8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2918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333E2C-C174-4526-BF7C-3B09263359BB}" type="datetimeFigureOut">
              <a:rPr lang="en-US" smtClean="0"/>
              <a:t>11/30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F04226-CC07-4248-AB56-E085485CA8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75347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333E2C-C174-4526-BF7C-3B09263359BB}" type="datetimeFigureOut">
              <a:rPr lang="en-US" smtClean="0"/>
              <a:t>11/30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F04226-CC07-4248-AB56-E085485CA8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09934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333E2C-C174-4526-BF7C-3B09263359BB}" type="datetimeFigureOut">
              <a:rPr lang="en-US" smtClean="0"/>
              <a:t>11/30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F04226-CC07-4248-AB56-E085485CA8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30316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333E2C-C174-4526-BF7C-3B09263359BB}" type="datetimeFigureOut">
              <a:rPr lang="en-US" smtClean="0"/>
              <a:t>11/30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F04226-CC07-4248-AB56-E085485CA8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41978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333E2C-C174-4526-BF7C-3B09263359BB}" type="datetimeFigureOut">
              <a:rPr lang="en-US" smtClean="0"/>
              <a:t>11/30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F04226-CC07-4248-AB56-E085485CA8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38181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333E2C-C174-4526-BF7C-3B09263359BB}" type="datetimeFigureOut">
              <a:rPr lang="en-US" smtClean="0"/>
              <a:t>11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F04226-CC07-4248-AB56-E085485CA8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83222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1307522" y="4495800"/>
            <a:ext cx="6248400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sz="1000" b="1" dirty="0">
                <a:latin typeface="Times New Roman" pitchFamily="18" charset="0"/>
                <a:cs typeface="Times New Roman" pitchFamily="18" charset="0"/>
              </a:rPr>
              <a:t>S6. Boxplots showing growth suppression effects of </a:t>
            </a:r>
            <a:r>
              <a:rPr lang="en-US" sz="1000" b="1" dirty="0" err="1">
                <a:latin typeface="Times New Roman" pitchFamily="18" charset="0"/>
                <a:cs typeface="Times New Roman" pitchFamily="18" charset="0"/>
              </a:rPr>
              <a:t>siRNA</a:t>
            </a:r>
            <a:r>
              <a:rPr lang="en-US" sz="1000" b="1" dirty="0">
                <a:latin typeface="Times New Roman" pitchFamily="18" charset="0"/>
                <a:cs typeface="Times New Roman" pitchFamily="18" charset="0"/>
              </a:rPr>
              <a:t> knockdown experiments targeting the 26 vs. the 708 gene set.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Growth 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suppression was defined as ≥ 30%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loss in cell viability in 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at least one cell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line and labeled as “Minimum Survival Rate” in the y-axis. The boxplots show the median and the first and third quartile range (IQR) of the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Minimun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Survival Rate. 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The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whiskers show the 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minimum and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maximum values 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that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are within 1.5X the IQR, 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and the dots beyond the whisker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represent 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the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outliers defined as values beyond Q3+1.5XIQR 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or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Q1-1.5XIQR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.</a:t>
            </a:r>
            <a:endParaRPr lang="en-US" sz="1000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64822" y="787400"/>
            <a:ext cx="3733800" cy="3733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077717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</TotalTime>
  <Words>105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Fred Hutchinson Cancer Research Cen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Xu, Chang</dc:creator>
  <cp:lastModifiedBy>Xu, Chang</cp:lastModifiedBy>
  <cp:revision>12</cp:revision>
  <dcterms:created xsi:type="dcterms:W3CDTF">2012-08-18T01:26:52Z</dcterms:created>
  <dcterms:modified xsi:type="dcterms:W3CDTF">2012-12-01T00:51:08Z</dcterms:modified>
</cp:coreProperties>
</file>